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91" r:id="rId2"/>
  </p:sldIdLst>
  <p:sldSz cx="12192000" cy="6858000"/>
  <p:notesSz cx="6799263" cy="9929813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5EC237"/>
    <a:srgbClr val="CFEDC5"/>
    <a:srgbClr val="289BE9"/>
    <a:srgbClr val="60C239"/>
    <a:srgbClr val="2E9FEA"/>
    <a:srgbClr val="4B6098"/>
    <a:srgbClr val="D76F55"/>
    <a:srgbClr val="B24675"/>
    <a:srgbClr val="0D6565"/>
    <a:srgbClr val="58B3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ittlere Formatvorlage 2 - Akz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64" autoAdjust="0"/>
    <p:restoredTop sz="84091" autoAdjust="0"/>
  </p:normalViewPr>
  <p:slideViewPr>
    <p:cSldViewPr snapToGrid="0">
      <p:cViewPr varScale="1">
        <p:scale>
          <a:sx n="63" d="100"/>
          <a:sy n="63" d="100"/>
        </p:scale>
        <p:origin x="58" y="11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kis1.uke.de\dfs-k2\Groups-DFS-K2\ZD\ZGKJ\PHO-HIT-MED\S&#246;nksen\Projekte\ERN%20PaedCan%20Auswertung\Datensets%20f&#252;r%20Auswertung\Survey\results-survey383327_23.02.2024_Implementation_Supplement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0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de-DE" sz="16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ow did you learn about</a:t>
            </a:r>
            <a:r>
              <a:rPr lang="de-DE" sz="1600" baseline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the ERN PaedCan CNS tumor board?</a:t>
            </a:r>
            <a:endParaRPr lang="de-DE" sz="160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de-DE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cat>
            <c:strRef>
              <c:f>Converted_data_Learn_ERN!$A$2:$A$6</c:f>
              <c:strCache>
                <c:ptCount val="5"/>
                <c:pt idx="0">
                  <c:v>Colleagues</c:v>
                </c:pt>
                <c:pt idx="1">
                  <c:v>Conference</c:v>
                </c:pt>
                <c:pt idx="2">
                  <c:v>ERN website</c:v>
                </c:pt>
                <c:pt idx="3">
                  <c:v>CPMS website</c:v>
                </c:pt>
                <c:pt idx="4">
                  <c:v>E-mail newsletter</c:v>
                </c:pt>
              </c:strCache>
            </c:strRef>
          </c:cat>
          <c:val>
            <c:numRef>
              <c:f>Converted_data_Learn_ERN!$B$2:$B$6</c:f>
              <c:numCache>
                <c:formatCode>0.00%</c:formatCode>
                <c:ptCount val="5"/>
                <c:pt idx="0">
                  <c:v>0.77</c:v>
                </c:pt>
                <c:pt idx="1">
                  <c:v>0.44</c:v>
                </c:pt>
                <c:pt idx="2">
                  <c:v>0.33</c:v>
                </c:pt>
                <c:pt idx="3">
                  <c:v>0.11</c:v>
                </c:pt>
                <c:pt idx="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464-4496-B63C-45FC50264D5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842089584"/>
        <c:axId val="1842092912"/>
      </c:barChart>
      <c:catAx>
        <c:axId val="18420895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842092912"/>
        <c:crosses val="autoZero"/>
        <c:auto val="1"/>
        <c:lblAlgn val="ctr"/>
        <c:lblOffset val="100"/>
        <c:noMultiLvlLbl val="0"/>
      </c:catAx>
      <c:valAx>
        <c:axId val="1842092912"/>
        <c:scaling>
          <c:orientation val="minMax"/>
          <c:max val="1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de-DE"/>
          </a:p>
        </c:txPr>
        <c:crossAx val="184208958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760" cy="498167"/>
          </a:xfrm>
          <a:prstGeom prst="rect">
            <a:avLst/>
          </a:prstGeom>
        </p:spPr>
        <p:txBody>
          <a:bodyPr vert="horz" lIns="92049" tIns="46024" rIns="92049" bIns="46024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51902" y="0"/>
            <a:ext cx="2945760" cy="498167"/>
          </a:xfrm>
          <a:prstGeom prst="rect">
            <a:avLst/>
          </a:prstGeom>
        </p:spPr>
        <p:txBody>
          <a:bodyPr vert="horz" lIns="92049" tIns="46024" rIns="92049" bIns="46024" rtlCol="0"/>
          <a:lstStyle>
            <a:lvl1pPr algn="r">
              <a:defRPr sz="1200"/>
            </a:lvl1pPr>
          </a:lstStyle>
          <a:p>
            <a:fld id="{920D1BCF-FDAF-48DF-97B6-02AAE20B627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0" y="9431647"/>
            <a:ext cx="2945760" cy="498167"/>
          </a:xfrm>
          <a:prstGeom prst="rect">
            <a:avLst/>
          </a:prstGeom>
        </p:spPr>
        <p:txBody>
          <a:bodyPr vert="horz" lIns="92049" tIns="46024" rIns="92049" bIns="46024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51902" y="9431647"/>
            <a:ext cx="2945760" cy="498167"/>
          </a:xfrm>
          <a:prstGeom prst="rect">
            <a:avLst/>
          </a:prstGeom>
        </p:spPr>
        <p:txBody>
          <a:bodyPr vert="horz" lIns="92049" tIns="46024" rIns="92049" bIns="46024" rtlCol="0" anchor="b"/>
          <a:lstStyle>
            <a:lvl1pPr algn="r">
              <a:defRPr sz="1200"/>
            </a:lvl1pPr>
          </a:lstStyle>
          <a:p>
            <a:fld id="{19DE4D78-34FC-45A0-962C-06314AA8C896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058086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347" cy="498215"/>
          </a:xfrm>
          <a:prstGeom prst="rect">
            <a:avLst/>
          </a:prstGeom>
        </p:spPr>
        <p:txBody>
          <a:bodyPr vert="horz" lIns="92049" tIns="46024" rIns="92049" bIns="46024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51344" y="0"/>
            <a:ext cx="2946347" cy="498215"/>
          </a:xfrm>
          <a:prstGeom prst="rect">
            <a:avLst/>
          </a:prstGeom>
        </p:spPr>
        <p:txBody>
          <a:bodyPr vert="horz" lIns="92049" tIns="46024" rIns="92049" bIns="46024" rtlCol="0"/>
          <a:lstStyle>
            <a:lvl1pPr algn="r">
              <a:defRPr sz="1200"/>
            </a:lvl1pPr>
          </a:lstStyle>
          <a:p>
            <a:fld id="{842FBD59-7270-4890-A2D8-55FFEF1DDC9D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419100" y="1239838"/>
            <a:ext cx="5961063" cy="33528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049" tIns="46024" rIns="92049" bIns="46024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927" y="4778724"/>
            <a:ext cx="5439410" cy="3909864"/>
          </a:xfrm>
          <a:prstGeom prst="rect">
            <a:avLst/>
          </a:prstGeom>
        </p:spPr>
        <p:txBody>
          <a:bodyPr vert="horz" lIns="92049" tIns="46024" rIns="92049" bIns="46024" rtlCol="0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31600"/>
            <a:ext cx="2946347" cy="498214"/>
          </a:xfrm>
          <a:prstGeom prst="rect">
            <a:avLst/>
          </a:prstGeom>
        </p:spPr>
        <p:txBody>
          <a:bodyPr vert="horz" lIns="92049" tIns="46024" rIns="92049" bIns="46024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51344" y="9431600"/>
            <a:ext cx="2946347" cy="498214"/>
          </a:xfrm>
          <a:prstGeom prst="rect">
            <a:avLst/>
          </a:prstGeom>
        </p:spPr>
        <p:txBody>
          <a:bodyPr vert="horz" lIns="92049" tIns="46024" rIns="92049" bIns="46024" rtlCol="0" anchor="b"/>
          <a:lstStyle>
            <a:lvl1pPr algn="r">
              <a:defRPr sz="1200"/>
            </a:lvl1pPr>
          </a:lstStyle>
          <a:p>
            <a:fld id="{BF3843F2-C3C8-4FAC-95D1-6B53E806113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1194244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One-year follow-up of the new European Reference Network for pediatric cancers (ERN PaedCan) tumor board for pediatric CNS tumors: Lessons learnt and future prospects, </a:t>
            </a:r>
            <a:endParaRPr lang="de-DE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Journal of Neuro-Oncology </a:t>
            </a:r>
            <a:endParaRPr lang="de-DE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r>
              <a:rPr lang="de-DE" sz="1200" kern="1200" dirty="0" err="1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uthors</a:t>
            </a:r>
            <a:r>
              <a:rPr lang="de-DE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: Marthe Sönksen, Brigitte Bison, Lisa Bußenius, Jelena Rascon, Denise Obrecht-Sturm, Barry Pizer, Katrin Scheinemann, Martin Schalling, Ruth Ladenstein, Martin Mynarek, Stefan Rutkowski</a:t>
            </a:r>
          </a:p>
          <a:p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orresponding author: Stefan Rutkowski, Pediatric Hematology and Oncology, University Medical Center Hamburg-Eppendorf, Hamburg, Germany, s.rutkowski@uke.de</a:t>
            </a:r>
            <a:endParaRPr lang="de-DE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F3843F2-C3C8-4FAC-95D1-6B53E806113B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6773776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572180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035269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450703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951634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42049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81943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90960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34704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780738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5940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443198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BCA97D-3A09-474F-BF64-0462995101DB}" type="datetimeFigureOut">
              <a:rPr lang="de-DE" smtClean="0"/>
              <a:t>17.12.2024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8DEE5A-66A8-429B-B3A1-DF3F1A5E6671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68462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feld 13"/>
          <p:cNvSpPr txBox="1"/>
          <p:nvPr/>
        </p:nvSpPr>
        <p:spPr>
          <a:xfrm>
            <a:off x="408313" y="6437406"/>
            <a:ext cx="98740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b="1" dirty="0" err="1" smtClean="0"/>
              <a:t>Supplementary</a:t>
            </a:r>
            <a:r>
              <a:rPr lang="de-DE" sz="1400" b="1" dirty="0" smtClean="0"/>
              <a:t> Fig. 1. </a:t>
            </a:r>
            <a:r>
              <a:rPr lang="en-US" sz="1400" dirty="0"/>
              <a:t>Sources of familiarity with the ERN PaedCan CNS tumor </a:t>
            </a:r>
            <a:r>
              <a:rPr lang="en-US" sz="1400" dirty="0" smtClean="0"/>
              <a:t>board (multiple answers possible) </a:t>
            </a:r>
            <a:endParaRPr lang="de-DE" sz="1400" dirty="0"/>
          </a:p>
        </p:txBody>
      </p:sp>
      <p:graphicFrame>
        <p:nvGraphicFramePr>
          <p:cNvPr id="8" name="Diagramm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76538603"/>
              </p:ext>
            </p:extLst>
          </p:nvPr>
        </p:nvGraphicFramePr>
        <p:xfrm>
          <a:off x="2184594" y="1154934"/>
          <a:ext cx="7304639" cy="43827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19802756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9</Words>
  <Application>Microsoft Office PowerPoint</Application>
  <PresentationFormat>Breitbild</PresentationFormat>
  <Paragraphs>7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UK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bbildungen Fanconi MB Paper</dc:title>
  <dc:creator>Sönksen, Marthe</dc:creator>
  <cp:lastModifiedBy>Sönksen, Marthe</cp:lastModifiedBy>
  <cp:revision>539</cp:revision>
  <cp:lastPrinted>2024-03-12T18:27:52Z</cp:lastPrinted>
  <dcterms:created xsi:type="dcterms:W3CDTF">2023-04-12T12:26:11Z</dcterms:created>
  <dcterms:modified xsi:type="dcterms:W3CDTF">2024-12-17T17:59:28Z</dcterms:modified>
</cp:coreProperties>
</file>